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48"/>
    <p:restoredTop sz="94694"/>
  </p:normalViewPr>
  <p:slideViewPr>
    <p:cSldViewPr snapToGrid="0" showGuides="1">
      <p:cViewPr varScale="1">
        <p:scale>
          <a:sx n="81" d="100"/>
          <a:sy n="81" d="100"/>
        </p:scale>
        <p:origin x="3168" y="17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oshimichi Onuma" userId="3c02b7618b88d217" providerId="LiveId" clId="{F8D2A7B8-5991-7B45-A54E-6A9D5970741E}"/>
    <pc:docChg chg="modSld">
      <pc:chgData name="Toshimichi Onuma" userId="3c02b7618b88d217" providerId="LiveId" clId="{F8D2A7B8-5991-7B45-A54E-6A9D5970741E}" dt="2024-06-23T00:38:10.775" v="1" actId="20577"/>
      <pc:docMkLst>
        <pc:docMk/>
      </pc:docMkLst>
      <pc:sldChg chg="modSp mod">
        <pc:chgData name="Toshimichi Onuma" userId="3c02b7618b88d217" providerId="LiveId" clId="{F8D2A7B8-5991-7B45-A54E-6A9D5970741E}" dt="2024-06-23T00:38:10.775" v="1" actId="20577"/>
        <pc:sldMkLst>
          <pc:docMk/>
          <pc:sldMk cId="295979828" sldId="256"/>
        </pc:sldMkLst>
        <pc:spChg chg="mod">
          <ac:chgData name="Toshimichi Onuma" userId="3c02b7618b88d217" providerId="LiveId" clId="{F8D2A7B8-5991-7B45-A54E-6A9D5970741E}" dt="2024-06-23T00:38:10.775" v="1" actId="20577"/>
          <ac:spMkLst>
            <pc:docMk/>
            <pc:sldMk cId="295979828" sldId="256"/>
            <ac:spMk id="4" creationId="{298F9FB4-A334-3B32-983B-F1B831177ADC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101682-E53F-2740-A2D3-0DF62881CAB8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2F1EE2-8EC8-C642-9882-504DE39BB3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4562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2F1EE2-8EC8-C642-9882-504DE39BB33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75857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2F1EE2-8EC8-C642-9882-504DE39BB33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86752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2F1EE2-8EC8-C642-9882-504DE39BB335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44330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060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3476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46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9453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437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984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67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8429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347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1889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9163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9954EC-B6ED-E74B-988E-B23A9A0C75ED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EFE471-2A63-4248-9B52-9C83C7EE5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048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3A649A-D644-AB74-0045-CA46B15C17C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ractal dimension, circularity, and solidity of cell clusters in liquid-based endometrial cytology are potentially useful for endometrial cancer detection and prognosis prediction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824A29-15F3-AC16-C70F-9931A80EBC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707440"/>
            <a:ext cx="5143500" cy="372546"/>
          </a:xfrm>
        </p:spPr>
        <p:txBody>
          <a:bodyPr/>
          <a:lstStyle/>
          <a:p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Toshimichi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Onum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98F9FB4-A334-3B32-983B-F1B831177ADC}"/>
              </a:ext>
            </a:extLst>
          </p:cNvPr>
          <p:cNvSpPr txBox="1"/>
          <p:nvPr/>
        </p:nvSpPr>
        <p:spPr>
          <a:xfrm>
            <a:off x="1797269" y="2126734"/>
            <a:ext cx="32634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979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667D43E6-C70B-5C0C-679D-767B0AD204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2380225"/>
              </p:ext>
            </p:extLst>
          </p:nvPr>
        </p:nvGraphicFramePr>
        <p:xfrm>
          <a:off x="400671" y="679450"/>
          <a:ext cx="6056658" cy="1630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6563">
                  <a:extLst>
                    <a:ext uri="{9D8B030D-6E8A-4147-A177-3AD203B41FA5}">
                      <a16:colId xmlns:a16="http://schemas.microsoft.com/office/drawing/2014/main" val="2488391489"/>
                    </a:ext>
                  </a:extLst>
                </a:gridCol>
                <a:gridCol w="1025453">
                  <a:extLst>
                    <a:ext uri="{9D8B030D-6E8A-4147-A177-3AD203B41FA5}">
                      <a16:colId xmlns:a16="http://schemas.microsoft.com/office/drawing/2014/main" val="296112896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2611902190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80346904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72375141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1243250449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51967442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3348564482"/>
                    </a:ext>
                  </a:extLst>
                </a:gridCol>
              </a:tblGrid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ange</a:t>
                      </a: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566996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238025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ix (n=92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01516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226788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37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6084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0933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4386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456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2040394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 pix (n=1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8450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62912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959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935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909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037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668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extLst>
                  <a:ext uri="{0D108BD9-81ED-4DB2-BD59-A6C34878D82A}">
                    <a16:rowId xmlns:a16="http://schemas.microsoft.com/office/drawing/2014/main" val="351586542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H pix (n=1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6496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97853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976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741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0692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802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064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extLst>
                  <a:ext uri="{0D108BD9-81ED-4DB2-BD59-A6C34878D82A}">
                    <a16:rowId xmlns:a16="http://schemas.microsoft.com/office/drawing/2014/main" val="1567836694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1 pix (n=4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6563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945096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288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661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6882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37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095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extLst>
                  <a:ext uri="{0D108BD9-81ED-4DB2-BD59-A6C34878D82A}">
                    <a16:rowId xmlns:a16="http://schemas.microsoft.com/office/drawing/2014/main" val="3557219051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2 pix (n=1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64579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62152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1492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046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466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644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069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extLst>
                  <a:ext uri="{0D108BD9-81ED-4DB2-BD59-A6C34878D82A}">
                    <a16:rowId xmlns:a16="http://schemas.microsoft.com/office/drawing/2014/main" val="2092399070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3 pix (n=1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401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242647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6626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2452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906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2844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945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extLst>
                  <a:ext uri="{0D108BD9-81ED-4DB2-BD59-A6C34878D82A}">
                    <a16:rowId xmlns:a16="http://schemas.microsoft.com/office/drawing/2014/main" val="345288046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†Others pix (n=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3098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572246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206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389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557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6063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4138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9214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BADD2CC-98D0-0678-EBE1-BB4FD3B96D9E}"/>
              </a:ext>
            </a:extLst>
          </p:cNvPr>
          <p:cNvSpPr txBox="1"/>
          <p:nvPr/>
        </p:nvSpPr>
        <p:spPr>
          <a:xfrm>
            <a:off x="280021" y="241300"/>
            <a:ext cx="462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ble S1 The mean and range values of Perimeter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E1D7A18-65C5-7EF9-7C92-172AA684A31E}"/>
              </a:ext>
            </a:extLst>
          </p:cNvPr>
          <p:cNvSpPr txBox="1"/>
          <p:nvPr/>
        </p:nvSpPr>
        <p:spPr>
          <a:xfrm>
            <a:off x="336550" y="2501864"/>
            <a:ext cx="612077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ixels (pix); standard deviation (SD);  endometrial hyperplasia without atypia (EH); atypical endometrial hyperplasia (AEH); endometrioid carcinoma (EM); grade (G) </a:t>
            </a:r>
          </a:p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†: Serous and clear cell carcinoma</a:t>
            </a: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FA23AEDC-A1C6-9529-204D-CB8DD17D2E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2481051"/>
              </p:ext>
            </p:extLst>
          </p:nvPr>
        </p:nvGraphicFramePr>
        <p:xfrm>
          <a:off x="457200" y="3810120"/>
          <a:ext cx="6056658" cy="1630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6563">
                  <a:extLst>
                    <a:ext uri="{9D8B030D-6E8A-4147-A177-3AD203B41FA5}">
                      <a16:colId xmlns:a16="http://schemas.microsoft.com/office/drawing/2014/main" val="2488391489"/>
                    </a:ext>
                  </a:extLst>
                </a:gridCol>
                <a:gridCol w="1025453">
                  <a:extLst>
                    <a:ext uri="{9D8B030D-6E8A-4147-A177-3AD203B41FA5}">
                      <a16:colId xmlns:a16="http://schemas.microsoft.com/office/drawing/2014/main" val="296112896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2611902190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80346904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72375141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1243250449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51967442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3348564482"/>
                    </a:ext>
                  </a:extLst>
                </a:gridCol>
              </a:tblGrid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ange</a:t>
                      </a: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566996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238025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ix (n=92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28736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74279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645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731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215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950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092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2040394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 pix (n=1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5979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1888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74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17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672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76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554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1586542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H pix (n=1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60923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3932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395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1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47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028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01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67836694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1 pix (n=4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6360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8976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5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815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43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31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349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7219051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2 pix (n=1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87256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2367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3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74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4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624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2399070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3 pix (n=1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808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0183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73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018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64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0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936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288046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†Others pix (n=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63965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183954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766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8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054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339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238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9214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3026669-3DC9-156F-540B-464D6B530524}"/>
              </a:ext>
            </a:extLst>
          </p:cNvPr>
          <p:cNvSpPr txBox="1"/>
          <p:nvPr/>
        </p:nvSpPr>
        <p:spPr>
          <a:xfrm>
            <a:off x="336550" y="3371970"/>
            <a:ext cx="462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ble S2 The mean and range values of Fit ellipse Major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A09EDEF-9B58-E019-5CB5-44989407A463}"/>
              </a:ext>
            </a:extLst>
          </p:cNvPr>
          <p:cNvSpPr txBox="1"/>
          <p:nvPr/>
        </p:nvSpPr>
        <p:spPr>
          <a:xfrm>
            <a:off x="393079" y="5632534"/>
            <a:ext cx="612077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ixels (pix); standard deviation (SD);  endometrial hyperplasia without atypia (EH); atypical endometrial hyperplasia (AEH); endometrioid carcinoma (EM); grade (G) </a:t>
            </a:r>
          </a:p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†: Serous and clear cell carcinoma</a:t>
            </a:r>
          </a:p>
        </p:txBody>
      </p:sp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AFA1C8CE-B5A8-47F7-8283-FAEBE64C7F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0235350"/>
              </p:ext>
            </p:extLst>
          </p:nvPr>
        </p:nvGraphicFramePr>
        <p:xfrm>
          <a:off x="513729" y="6896305"/>
          <a:ext cx="6056658" cy="1630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6563">
                  <a:extLst>
                    <a:ext uri="{9D8B030D-6E8A-4147-A177-3AD203B41FA5}">
                      <a16:colId xmlns:a16="http://schemas.microsoft.com/office/drawing/2014/main" val="2488391489"/>
                    </a:ext>
                  </a:extLst>
                </a:gridCol>
                <a:gridCol w="1025453">
                  <a:extLst>
                    <a:ext uri="{9D8B030D-6E8A-4147-A177-3AD203B41FA5}">
                      <a16:colId xmlns:a16="http://schemas.microsoft.com/office/drawing/2014/main" val="296112896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2611902190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80346904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72375141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1243250449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51967442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3348564482"/>
                    </a:ext>
                  </a:extLst>
                </a:gridCol>
              </a:tblGrid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ange</a:t>
                      </a: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566996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238025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ix (n=92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0307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46317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295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7728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973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250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007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2040394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 pix (n=1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7664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51815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68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98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26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29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668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1586542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H pix (n=1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606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95695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26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98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2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427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957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67836694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1 pix (n=4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21848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7549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25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88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2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454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529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7219051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2 pix (n=1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31186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15028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75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083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97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383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357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2399070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3 pix (n=1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94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84092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615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935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7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434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935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288046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†Others pix (n=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32648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737319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415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967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474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67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106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9214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27829D9-5B12-76C8-E70C-448814AF5A03}"/>
              </a:ext>
            </a:extLst>
          </p:cNvPr>
          <p:cNvSpPr txBox="1"/>
          <p:nvPr/>
        </p:nvSpPr>
        <p:spPr>
          <a:xfrm>
            <a:off x="393079" y="6458155"/>
            <a:ext cx="462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ble S3 The mean and range values of Fit ellipse Minor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72FEDBF-22C5-D306-2DC7-1A17C8DF599C}"/>
              </a:ext>
            </a:extLst>
          </p:cNvPr>
          <p:cNvSpPr txBox="1"/>
          <p:nvPr/>
        </p:nvSpPr>
        <p:spPr>
          <a:xfrm>
            <a:off x="457200" y="8693319"/>
            <a:ext cx="612077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ixels (pix); standard deviation (SD);  endometrial hyperplasia without atypia (EH); atypical endometrial hyperplasia (AEH); endometrioid carcinoma (EM); grade (G) </a:t>
            </a:r>
          </a:p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†: Serous and clear cell carcinoma</a:t>
            </a:r>
          </a:p>
        </p:txBody>
      </p:sp>
    </p:spTree>
    <p:extLst>
      <p:ext uri="{BB962C8B-B14F-4D97-AF65-F5344CB8AC3E}">
        <p14:creationId xmlns:p14="http://schemas.microsoft.com/office/powerpoint/2010/main" val="937371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667D43E6-C70B-5C0C-679D-767B0AD204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7971651"/>
              </p:ext>
            </p:extLst>
          </p:nvPr>
        </p:nvGraphicFramePr>
        <p:xfrm>
          <a:off x="400671" y="679450"/>
          <a:ext cx="6056658" cy="1630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6563">
                  <a:extLst>
                    <a:ext uri="{9D8B030D-6E8A-4147-A177-3AD203B41FA5}">
                      <a16:colId xmlns:a16="http://schemas.microsoft.com/office/drawing/2014/main" val="2488391489"/>
                    </a:ext>
                  </a:extLst>
                </a:gridCol>
                <a:gridCol w="1025453">
                  <a:extLst>
                    <a:ext uri="{9D8B030D-6E8A-4147-A177-3AD203B41FA5}">
                      <a16:colId xmlns:a16="http://schemas.microsoft.com/office/drawing/2014/main" val="296112896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2611902190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80346904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72375141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1243250449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51967442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3348564482"/>
                    </a:ext>
                  </a:extLst>
                </a:gridCol>
              </a:tblGrid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ange</a:t>
                      </a: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566996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238025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ix (n=92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7.9933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43505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4.71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4.9084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7.923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1.2963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9.208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2040394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 pix (n=1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0.719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97846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2.45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0.075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1.230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2.26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5.709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1586542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H pix (n=1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9.927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5775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9.7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5.90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9.00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4.07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9.578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67836694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1 pix (n=4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0.4941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91778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2.63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7.52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9.95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3.10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3.282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7219051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2 pix (n=1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0.8138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9342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4.67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8.028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0.39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2.92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9.512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2399070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3 pix (n=1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1.41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8387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1.89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0.268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2.691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3.457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8.196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288046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†Others pix (n=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9.8017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02692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3.91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7.892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8.724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1.846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6.498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9214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BADD2CC-98D0-0678-EBE1-BB4FD3B96D9E}"/>
              </a:ext>
            </a:extLst>
          </p:cNvPr>
          <p:cNvSpPr txBox="1"/>
          <p:nvPr/>
        </p:nvSpPr>
        <p:spPr>
          <a:xfrm>
            <a:off x="280021" y="241300"/>
            <a:ext cx="462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ble S4 The mean and range values of Angl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E1D7A18-65C5-7EF9-7C92-172AA684A31E}"/>
              </a:ext>
            </a:extLst>
          </p:cNvPr>
          <p:cNvSpPr txBox="1"/>
          <p:nvPr/>
        </p:nvSpPr>
        <p:spPr>
          <a:xfrm>
            <a:off x="336550" y="2501864"/>
            <a:ext cx="612077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ixels (pix); standard deviation (SD);  endometrial hyperplasia without atypia (EH); atypical endometrial hyperplasia (AEH); endometrioid carcinoma (EM); grade (G) </a:t>
            </a:r>
          </a:p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†: Serous and clear cell carcinoma</a:t>
            </a: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FA23AEDC-A1C6-9529-204D-CB8DD17D2E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177368"/>
              </p:ext>
            </p:extLst>
          </p:nvPr>
        </p:nvGraphicFramePr>
        <p:xfrm>
          <a:off x="457200" y="3810120"/>
          <a:ext cx="6056658" cy="1630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6563">
                  <a:extLst>
                    <a:ext uri="{9D8B030D-6E8A-4147-A177-3AD203B41FA5}">
                      <a16:colId xmlns:a16="http://schemas.microsoft.com/office/drawing/2014/main" val="2488391489"/>
                    </a:ext>
                  </a:extLst>
                </a:gridCol>
                <a:gridCol w="1025453">
                  <a:extLst>
                    <a:ext uri="{9D8B030D-6E8A-4147-A177-3AD203B41FA5}">
                      <a16:colId xmlns:a16="http://schemas.microsoft.com/office/drawing/2014/main" val="296112896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2611902190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80346904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72375141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1243250449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51967442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3348564482"/>
                    </a:ext>
                  </a:extLst>
                </a:gridCol>
              </a:tblGrid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ange</a:t>
                      </a: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566996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238025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ix (n=92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1656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417755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26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601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3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2040394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 pix (n=1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0153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3634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53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5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4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62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1586542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H pix (n=1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432414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4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19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67836694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1 pix (n=4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2018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44797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7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74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9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19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7219051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2 pix (n=1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91366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6969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90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3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94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56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2399070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3 pix (n=1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903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833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3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6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55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288046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†Others pix (n=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538143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19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7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6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78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9214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3026669-3DC9-156F-540B-464D6B530524}"/>
              </a:ext>
            </a:extLst>
          </p:cNvPr>
          <p:cNvSpPr txBox="1"/>
          <p:nvPr/>
        </p:nvSpPr>
        <p:spPr>
          <a:xfrm>
            <a:off x="336550" y="3371970"/>
            <a:ext cx="462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ble S5 The mean and range values of Circularity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A09EDEF-9B58-E019-5CB5-44989407A463}"/>
              </a:ext>
            </a:extLst>
          </p:cNvPr>
          <p:cNvSpPr txBox="1"/>
          <p:nvPr/>
        </p:nvSpPr>
        <p:spPr>
          <a:xfrm>
            <a:off x="393079" y="5632534"/>
            <a:ext cx="612077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ixels (pix); standard deviation (SD);  endometrial hyperplasia without atypia (EH); atypical endometrial hyperplasia (AEH); endometrioid carcinoma (EM); grade (G) </a:t>
            </a:r>
          </a:p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†: Serous and clear cell carcinoma</a:t>
            </a:r>
          </a:p>
        </p:txBody>
      </p:sp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AFA1C8CE-B5A8-47F7-8283-FAEBE64C7F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8023777"/>
              </p:ext>
            </p:extLst>
          </p:nvPr>
        </p:nvGraphicFramePr>
        <p:xfrm>
          <a:off x="513729" y="6896305"/>
          <a:ext cx="6056658" cy="1630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6563">
                  <a:extLst>
                    <a:ext uri="{9D8B030D-6E8A-4147-A177-3AD203B41FA5}">
                      <a16:colId xmlns:a16="http://schemas.microsoft.com/office/drawing/2014/main" val="2488391489"/>
                    </a:ext>
                  </a:extLst>
                </a:gridCol>
                <a:gridCol w="1025453">
                  <a:extLst>
                    <a:ext uri="{9D8B030D-6E8A-4147-A177-3AD203B41FA5}">
                      <a16:colId xmlns:a16="http://schemas.microsoft.com/office/drawing/2014/main" val="296112896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2611902190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80346904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72375141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1243250449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51967442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3348564482"/>
                    </a:ext>
                  </a:extLst>
                </a:gridCol>
              </a:tblGrid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ange</a:t>
                      </a: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566996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238025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ix (n=92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.9288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87192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692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494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.673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.178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.85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2040394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 pix (n=1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549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0796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45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.53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653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.08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.328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1586542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H pix (n=1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736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6287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72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.09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261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.2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7.596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67836694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1 pix (n=4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235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3973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934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502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.3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.850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7.871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7219051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2 pix (n=1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87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39885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97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.149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14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.48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7.636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2399070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3 pix (n=1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493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0743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15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97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10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.05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.467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288046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†Others pix (n=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.5583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57300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192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.231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.326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.889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.148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9214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27829D9-5B12-76C8-E70C-448814AF5A03}"/>
              </a:ext>
            </a:extLst>
          </p:cNvPr>
          <p:cNvSpPr txBox="1"/>
          <p:nvPr/>
        </p:nvSpPr>
        <p:spPr>
          <a:xfrm>
            <a:off x="393079" y="6458155"/>
            <a:ext cx="462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ble S6 The mean and range values of Max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Feret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diameter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72FEDBF-22C5-D306-2DC7-1A17C8DF599C}"/>
              </a:ext>
            </a:extLst>
          </p:cNvPr>
          <p:cNvSpPr txBox="1"/>
          <p:nvPr/>
        </p:nvSpPr>
        <p:spPr>
          <a:xfrm>
            <a:off x="457200" y="8693319"/>
            <a:ext cx="612077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ixels (pix); standard deviation (SD);  endometrial hyperplasia without atypia (EH); atypical endometrial hyperplasia (AEH); endometrioid carcinoma (EM); grade (G) </a:t>
            </a:r>
          </a:p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†: Serous and clear cell carcinoma</a:t>
            </a:r>
          </a:p>
        </p:txBody>
      </p:sp>
    </p:spTree>
    <p:extLst>
      <p:ext uri="{BB962C8B-B14F-4D97-AF65-F5344CB8AC3E}">
        <p14:creationId xmlns:p14="http://schemas.microsoft.com/office/powerpoint/2010/main" val="28747800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667D43E6-C70B-5C0C-679D-767B0AD204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6067883"/>
              </p:ext>
            </p:extLst>
          </p:nvPr>
        </p:nvGraphicFramePr>
        <p:xfrm>
          <a:off x="400671" y="679450"/>
          <a:ext cx="6056658" cy="1630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6563">
                  <a:extLst>
                    <a:ext uri="{9D8B030D-6E8A-4147-A177-3AD203B41FA5}">
                      <a16:colId xmlns:a16="http://schemas.microsoft.com/office/drawing/2014/main" val="2488391489"/>
                    </a:ext>
                  </a:extLst>
                </a:gridCol>
                <a:gridCol w="1025453">
                  <a:extLst>
                    <a:ext uri="{9D8B030D-6E8A-4147-A177-3AD203B41FA5}">
                      <a16:colId xmlns:a16="http://schemas.microsoft.com/office/drawing/2014/main" val="296112896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2611902190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80346904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72375141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1243250449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51967442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3348564482"/>
                    </a:ext>
                  </a:extLst>
                </a:gridCol>
              </a:tblGrid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ange</a:t>
                      </a: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566996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238025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ix (n=92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32325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08426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414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5548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158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9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596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2040394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 pix (n=1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7350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83967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478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26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78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29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722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1586542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H pix (n=1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7617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584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0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907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54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593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784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67836694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1 pix (n=4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6045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728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14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65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183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533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431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7219051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2 pix (n=1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9471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0996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41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02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535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444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846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2399070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3 pix (n=1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594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97305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66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91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388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0293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578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288046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†Others pix (n=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91017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92009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374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123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392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696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96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9214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BADD2CC-98D0-0678-EBE1-BB4FD3B96D9E}"/>
              </a:ext>
            </a:extLst>
          </p:cNvPr>
          <p:cNvSpPr txBox="1"/>
          <p:nvPr/>
        </p:nvSpPr>
        <p:spPr>
          <a:xfrm>
            <a:off x="280021" y="241300"/>
            <a:ext cx="462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ble S7 The mean and range values of Min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Feret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diameter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E1D7A18-65C5-7EF9-7C92-172AA684A31E}"/>
              </a:ext>
            </a:extLst>
          </p:cNvPr>
          <p:cNvSpPr txBox="1"/>
          <p:nvPr/>
        </p:nvSpPr>
        <p:spPr>
          <a:xfrm>
            <a:off x="336550" y="2501864"/>
            <a:ext cx="612077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ixels (pix); standard deviation (SD);  endometrial hyperplasia without atypia (EH); atypical endometrial hyperplasia (AEH); endometrioid carcinoma (EM); grade (G) </a:t>
            </a:r>
          </a:p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†: Serous and clear cell carcinoma</a:t>
            </a: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FA23AEDC-A1C6-9529-204D-CB8DD17D2E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5591017"/>
              </p:ext>
            </p:extLst>
          </p:nvPr>
        </p:nvGraphicFramePr>
        <p:xfrm>
          <a:off x="457200" y="3810120"/>
          <a:ext cx="6056658" cy="1630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6563">
                  <a:extLst>
                    <a:ext uri="{9D8B030D-6E8A-4147-A177-3AD203B41FA5}">
                      <a16:colId xmlns:a16="http://schemas.microsoft.com/office/drawing/2014/main" val="2488391489"/>
                    </a:ext>
                  </a:extLst>
                </a:gridCol>
                <a:gridCol w="1025453">
                  <a:extLst>
                    <a:ext uri="{9D8B030D-6E8A-4147-A177-3AD203B41FA5}">
                      <a16:colId xmlns:a16="http://schemas.microsoft.com/office/drawing/2014/main" val="296112896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2611902190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80346904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72375141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1243250449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51967442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3348564482"/>
                    </a:ext>
                  </a:extLst>
                </a:gridCol>
              </a:tblGrid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ange</a:t>
                      </a: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566996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238025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ix (n=92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9547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06509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32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99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42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92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2040394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 pix (n=1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5523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5866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6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2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2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43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1586542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H pix (n=1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8823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04164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63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2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7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67836694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1 pix (n=4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2362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07609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88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2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79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7219051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2 pix (n=1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9542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63103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1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9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6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2399070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3 pix (n=1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93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5814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4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74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4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63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288046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†Others pix (n=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99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56985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38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19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1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7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48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9214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3026669-3DC9-156F-540B-464D6B530524}"/>
              </a:ext>
            </a:extLst>
          </p:cNvPr>
          <p:cNvSpPr txBox="1"/>
          <p:nvPr/>
        </p:nvSpPr>
        <p:spPr>
          <a:xfrm>
            <a:off x="336550" y="3371970"/>
            <a:ext cx="462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ble S8 The mean and range values of Solidity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A09EDEF-9B58-E019-5CB5-44989407A463}"/>
              </a:ext>
            </a:extLst>
          </p:cNvPr>
          <p:cNvSpPr txBox="1"/>
          <p:nvPr/>
        </p:nvSpPr>
        <p:spPr>
          <a:xfrm>
            <a:off x="393079" y="5632534"/>
            <a:ext cx="612077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ixels (pix); standard deviation (SD);  endometrial hyperplasia without atypia (EH); atypical endometrial hyperplasia (AEH); endometrioid carcinoma (EM); grade (G) </a:t>
            </a:r>
          </a:p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†: Serous and clear cell carcinoma</a:t>
            </a:r>
          </a:p>
        </p:txBody>
      </p:sp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AFA1C8CE-B5A8-47F7-8283-FAEBE64C7F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7173564"/>
              </p:ext>
            </p:extLst>
          </p:nvPr>
        </p:nvGraphicFramePr>
        <p:xfrm>
          <a:off x="513729" y="6896305"/>
          <a:ext cx="6056658" cy="1630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6563">
                  <a:extLst>
                    <a:ext uri="{9D8B030D-6E8A-4147-A177-3AD203B41FA5}">
                      <a16:colId xmlns:a16="http://schemas.microsoft.com/office/drawing/2014/main" val="2488391489"/>
                    </a:ext>
                  </a:extLst>
                </a:gridCol>
                <a:gridCol w="1025453">
                  <a:extLst>
                    <a:ext uri="{9D8B030D-6E8A-4147-A177-3AD203B41FA5}">
                      <a16:colId xmlns:a16="http://schemas.microsoft.com/office/drawing/2014/main" val="296112896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2611902190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80346904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723751413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1243250449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519674428"/>
                    </a:ext>
                  </a:extLst>
                </a:gridCol>
                <a:gridCol w="679107">
                  <a:extLst>
                    <a:ext uri="{9D8B030D-6E8A-4147-A177-3AD203B41FA5}">
                      <a16:colId xmlns:a16="http://schemas.microsoft.com/office/drawing/2014/main" val="3348564482"/>
                    </a:ext>
                  </a:extLst>
                </a:gridCol>
              </a:tblGrid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Range</a:t>
                      </a: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566996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238025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ix (n=92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9708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174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3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1693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8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22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680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2040394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 pix (n=1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017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269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6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6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0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7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69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1586542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H pix (n=1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7668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75156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9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7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7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611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67836694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1 pix (n=43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6951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11546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9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46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85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62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842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7219051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2 pix (n=1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907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162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6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6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76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625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798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2399070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 G3 pix (n=1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44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0073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8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5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56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626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664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2880462"/>
                  </a:ext>
                </a:extLst>
              </a:tr>
              <a:tr h="181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†Others pix (n=7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6794" marR="6794" marT="67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0051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24051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57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01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04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6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709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9214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27829D9-5B12-76C8-E70C-448814AF5A03}"/>
              </a:ext>
            </a:extLst>
          </p:cNvPr>
          <p:cNvSpPr txBox="1"/>
          <p:nvPr/>
        </p:nvSpPr>
        <p:spPr>
          <a:xfrm>
            <a:off x="393079" y="6458155"/>
            <a:ext cx="462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able S9 The mean and range values of Fractal dimensio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72FEDBF-22C5-D306-2DC7-1A17C8DF599C}"/>
              </a:ext>
            </a:extLst>
          </p:cNvPr>
          <p:cNvSpPr txBox="1"/>
          <p:nvPr/>
        </p:nvSpPr>
        <p:spPr>
          <a:xfrm>
            <a:off x="457200" y="8693319"/>
            <a:ext cx="612077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ixels (pix); standard deviation (SD);  endometrial hyperplasia without atypia (EH); atypical endometrial hyperplasia (AEH); endometrioid carcinoma (EM); grade (G) </a:t>
            </a:r>
          </a:p>
          <a:p>
            <a:r>
              <a:rPr kumimoji="1"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†: Serous and clear cell carcinoma</a:t>
            </a:r>
          </a:p>
        </p:txBody>
      </p:sp>
    </p:spTree>
    <p:extLst>
      <p:ext uri="{BB962C8B-B14F-4D97-AF65-F5344CB8AC3E}">
        <p14:creationId xmlns:p14="http://schemas.microsoft.com/office/powerpoint/2010/main" val="233377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</TotalTime>
  <Words>1489</Words>
  <Application>Microsoft Macintosh PowerPoint</Application>
  <PresentationFormat>A4 210 x 297 mm</PresentationFormat>
  <Paragraphs>609</Paragraphs>
  <Slides>4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Aptos</vt:lpstr>
      <vt:lpstr>Aptos Display</vt:lpstr>
      <vt:lpstr>Arial</vt:lpstr>
      <vt:lpstr>Office テーマ</vt:lpstr>
      <vt:lpstr>Fractal dimension, circularity, and solidity of cell clusters in liquid-based endometrial cytology are potentially useful for endometrial cancer detection and prognosis prediction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shimichi Onuma</dc:creator>
  <cp:lastModifiedBy>Toshimichi Onuma</cp:lastModifiedBy>
  <cp:revision>2</cp:revision>
  <dcterms:created xsi:type="dcterms:W3CDTF">2024-05-24T06:46:02Z</dcterms:created>
  <dcterms:modified xsi:type="dcterms:W3CDTF">2024-06-23T00:38:15Z</dcterms:modified>
</cp:coreProperties>
</file>